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680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86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568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459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159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625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674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89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684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230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600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4459C4-BC46-43C0-8C90-B703AAC51D9B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739E7A-C712-44DE-9717-1D35AFB290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801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2">
            <a:extLst>
              <a:ext uri="{FF2B5EF4-FFF2-40B4-BE49-F238E27FC236}">
                <a16:creationId xmlns:a16="http://schemas.microsoft.com/office/drawing/2014/main" id="{E9480508-7987-4A35-8B68-6F209697EAD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9" t="7387" b="4988"/>
          <a:stretch/>
        </p:blipFill>
        <p:spPr bwMode="auto">
          <a:xfrm>
            <a:off x="506249" y="2241362"/>
            <a:ext cx="4556625" cy="29553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B1D2752D-CF20-405B-9708-D1EDA1F72566}"/>
              </a:ext>
            </a:extLst>
          </p:cNvPr>
          <p:cNvSpPr txBox="1"/>
          <p:nvPr/>
        </p:nvSpPr>
        <p:spPr>
          <a:xfrm>
            <a:off x="2329620" y="1258361"/>
            <a:ext cx="10613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MUC16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5340708-4194-425D-9097-C53E2F2A741F}"/>
              </a:ext>
            </a:extLst>
          </p:cNvPr>
          <p:cNvGrpSpPr/>
          <p:nvPr/>
        </p:nvGrpSpPr>
        <p:grpSpPr>
          <a:xfrm>
            <a:off x="5062874" y="2669167"/>
            <a:ext cx="1708481" cy="1158862"/>
            <a:chOff x="9888437" y="1612086"/>
            <a:chExt cx="1801334" cy="1158862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E8C2D35-8C9E-43CD-BC1B-6DBB29C956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9822" t="19643" r="7166" b="64035"/>
            <a:stretch/>
          </p:blipFill>
          <p:spPr>
            <a:xfrm>
              <a:off x="10006431" y="1882694"/>
              <a:ext cx="281922" cy="888254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685B83F-3A4B-4922-84EA-964189A81D3C}"/>
                </a:ext>
              </a:extLst>
            </p:cNvPr>
            <p:cNvSpPr txBox="1"/>
            <p:nvPr/>
          </p:nvSpPr>
          <p:spPr>
            <a:xfrm>
              <a:off x="9888437" y="1612086"/>
              <a:ext cx="14242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ollection Typ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31B2487-CB29-4256-A529-311D5E5441FC}"/>
                </a:ext>
              </a:extLst>
            </p:cNvPr>
            <p:cNvSpPr txBox="1"/>
            <p:nvPr/>
          </p:nvSpPr>
          <p:spPr>
            <a:xfrm>
              <a:off x="10201006" y="1889918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Strom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945FEC6-20A8-48C4-AE3B-D6C0BD77A972}"/>
                </a:ext>
              </a:extLst>
            </p:cNvPr>
            <p:cNvSpPr txBox="1"/>
            <p:nvPr/>
          </p:nvSpPr>
          <p:spPr>
            <a:xfrm>
              <a:off x="10201005" y="2141487"/>
              <a:ext cx="14887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Enriched Tumor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5234AC78-3AB1-4198-AA6D-6EE73B8A3C3A}"/>
                </a:ext>
              </a:extLst>
            </p:cNvPr>
            <p:cNvSpPr txBox="1"/>
            <p:nvPr/>
          </p:nvSpPr>
          <p:spPr>
            <a:xfrm>
              <a:off x="10201006" y="2397964"/>
              <a:ext cx="14887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ulk Tissue</a:t>
              </a:r>
            </a:p>
          </p:txBody>
        </p:sp>
      </p:grpSp>
      <p:sp>
        <p:nvSpPr>
          <p:cNvPr id="26" name="Left Bracket 25">
            <a:extLst>
              <a:ext uri="{FF2B5EF4-FFF2-40B4-BE49-F238E27FC236}">
                <a16:creationId xmlns:a16="http://schemas.microsoft.com/office/drawing/2014/main" id="{832434EA-FF54-471D-A735-F175A823AE84}"/>
              </a:ext>
            </a:extLst>
          </p:cNvPr>
          <p:cNvSpPr/>
          <p:nvPr/>
        </p:nvSpPr>
        <p:spPr>
          <a:xfrm rot="5400000">
            <a:off x="2082612" y="1173700"/>
            <a:ext cx="92305" cy="1463040"/>
          </a:xfrm>
          <a:prstGeom prst="leftBracket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095D838-1C5C-4557-91E9-E9A8500CA475}"/>
              </a:ext>
            </a:extLst>
          </p:cNvPr>
          <p:cNvSpPr txBox="1"/>
          <p:nvPr/>
        </p:nvSpPr>
        <p:spPr>
          <a:xfrm>
            <a:off x="2009709" y="1584614"/>
            <a:ext cx="238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33646D-2AA2-407A-B369-9A66209328D4}"/>
              </a:ext>
            </a:extLst>
          </p:cNvPr>
          <p:cNvSpPr txBox="1"/>
          <p:nvPr/>
        </p:nvSpPr>
        <p:spPr>
          <a:xfrm rot="16200000">
            <a:off x="-645322" y="3276667"/>
            <a:ext cx="19338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lative Abundanc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012DC3C-AC4F-4DFF-A181-789BAD47B20E}"/>
              </a:ext>
            </a:extLst>
          </p:cNvPr>
          <p:cNvSpPr txBox="1"/>
          <p:nvPr/>
        </p:nvSpPr>
        <p:spPr>
          <a:xfrm>
            <a:off x="709181" y="1963281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Strom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2B5A4DF-2258-4333-B094-2FD5EC3A8E04}"/>
              </a:ext>
            </a:extLst>
          </p:cNvPr>
          <p:cNvSpPr txBox="1"/>
          <p:nvPr/>
        </p:nvSpPr>
        <p:spPr>
          <a:xfrm>
            <a:off x="2160884" y="1963280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Enriched Tumor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D172502-4043-4EDE-A694-A506DD434805}"/>
              </a:ext>
            </a:extLst>
          </p:cNvPr>
          <p:cNvSpPr txBox="1"/>
          <p:nvPr/>
        </p:nvSpPr>
        <p:spPr>
          <a:xfrm>
            <a:off x="3611879" y="1963280"/>
            <a:ext cx="1402086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Bulk Tissue</a:t>
            </a:r>
          </a:p>
        </p:txBody>
      </p:sp>
    </p:spTree>
    <p:extLst>
      <p:ext uri="{BB962C8B-B14F-4D97-AF65-F5344CB8AC3E}">
        <p14:creationId xmlns:p14="http://schemas.microsoft.com/office/powerpoint/2010/main" val="3487476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Allison Hunt</cp:lastModifiedBy>
  <cp:revision>1</cp:revision>
  <dcterms:created xsi:type="dcterms:W3CDTF">2024-01-04T20:27:49Z</dcterms:created>
  <dcterms:modified xsi:type="dcterms:W3CDTF">2024-01-04T20:28:10Z</dcterms:modified>
</cp:coreProperties>
</file>